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625" r:id="rId2"/>
    <p:sldId id="626" r:id="rId3"/>
    <p:sldId id="64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E7A15F-9BB7-4D62-9226-A37CD24B4F14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87FE0C-B5CD-42E1-A83E-72F36C102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195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last exposure type is represented by a blue dot (SARS-CoV-2 infection) and a black dot (mRNA COVID-19 vaccine)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X-axis: Time since an mRNA COVID-19 vaccine dose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Y-axis: Percent (%)</a:t>
            </a:r>
            <a:r>
              <a:rPr lang="en-US" sz="1800" kern="1200" dirty="0">
                <a:effectLst/>
                <a:latin typeface="Calibri" panose="020F0502020204030204" pitchFamily="34" charset="0"/>
                <a:ea typeface="Yu Mincho" panose="02020400000000000000" pitchFamily="18" charset="-128"/>
              </a:rPr>
              <a:t> Spike IgA Memory B Cells (MBC)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3857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last exposure type is represented by a blue dot (SARS-CoV-2 infection) and a black dot (mRNA COVID-19 vaccine)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X-axis: Time since an mRNA COVID-19 vaccine dose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Y-axis: Percent (%)</a:t>
            </a:r>
            <a:r>
              <a:rPr lang="en-US" sz="1800" kern="1200" dirty="0">
                <a:effectLst/>
                <a:latin typeface="Calibri" panose="020F0502020204030204" pitchFamily="34" charset="0"/>
                <a:ea typeface="Yu Mincho" panose="02020400000000000000" pitchFamily="18" charset="-128"/>
              </a:rPr>
              <a:t> Nucleocapsid IgG Memory B Cells (MBC)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7432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last exposure type is represented by a blue dot (SARS-CoV-2 infection) and a black dot (mRNA COVID-19 vaccine)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X-axis: Time since an mRNA COVID-19 vaccine dose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Y-axis: Percent (%)</a:t>
            </a:r>
            <a:r>
              <a:rPr lang="en-US" sz="1800" kern="1200" dirty="0">
                <a:effectLst/>
                <a:latin typeface="Calibri" panose="020F0502020204030204" pitchFamily="34" charset="0"/>
                <a:ea typeface="Yu Mincho" panose="02020400000000000000" pitchFamily="18" charset="-128"/>
              </a:rPr>
              <a:t> Nucleocapsid IgA Memory B Cells (MBC)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5258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21A04-0050-E7FC-9CC1-4A846B8080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D7B509-FE75-D293-FF7E-53A4135864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CBB75-CE7C-5F67-017A-8AA9F7925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DCF97D-B82A-210E-BD41-97194478E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D10D2F-1B95-1381-A17E-B4EF09E34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91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972F1-B89E-563E-BF23-DFCBC1A6E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F6ACAD-1EEC-8EF8-C7AB-680CECB29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059536-62E9-8732-286C-CFA2DEAE1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3D2ED-0C50-A4BF-1551-E27610BA7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51A70-3FBD-DE6F-6A7E-4B660799B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271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4F35B3-8771-B0D8-A5D6-A67688A8C2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2F2D3A-52C8-E782-3A13-5C360D0FE3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A76B9E-08C2-D11E-E027-11D1B80D3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A5BD83-7272-48C6-DFDE-8BAA19F57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0EE531-455A-B2E5-F18D-B506033B4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682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E28CCB-C788-141F-B0DB-7D1C50FC50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84FBA5-232D-507B-6F79-F76B081A51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3C63E6-875A-7FD3-8FA9-909FCD718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45B515-172B-31F8-575D-14756E87D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92C9F-1F4A-F59E-21C5-7AC3D822F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820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67E5C-EDB8-642C-F8EE-493C9ED127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CD2764-2368-54A3-8E70-E65E751C67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6D430-0EF3-D20E-9A58-52DBD4DA1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E61A1-1476-DF6A-105A-2D7ABEA52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F7739B-A4FA-CEC6-BF58-AD6FF1C88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339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657A3A-CD8A-F453-7FE8-02693E0044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949D92-8E01-AB67-C2F2-DA4F5E640A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135600-6CCC-B3D0-501C-71A38C5031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B870EC-DEF6-3080-7EAA-A0FD06221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EB0645-3DA0-9EAF-FC64-E10518249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D59BE8-9A66-7825-CD7A-ACBAEBEB7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906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7E703-1C86-D2CB-B707-A58812C22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635A5E-D73E-6DA4-DBC7-519A55FE5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25E83B-A515-BC16-733F-304899A88E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BFAA13-A4C8-AC0C-0F33-7BBDEE292E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1AF37D-8D81-55AA-C25B-EAE69BD863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D76DBA-46E9-5D40-EFBB-077C8DED9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B763C8-E7FB-5D15-51DA-22A178FCF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4F4D4B-021E-1558-D711-D6C5935E7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532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22D657-A0D1-12F1-0942-CA40E5C91F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2AD35E-8CEB-8093-DCF2-C599679F0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C6D854-909B-F5D4-0ACC-C61C87A34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0730C1-03CD-3EED-C4C5-362E480A6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627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EFE050-3717-26F3-E83C-2F9107943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2E60CE-AA22-2086-40E7-8120DF031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130654-F92F-F714-70CE-8DDD64AFC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580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951B8-EA06-9652-B8BA-56D738621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A4D829-3E71-C581-0F75-3437003D2D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ED5539-1FE5-BA95-E52E-32F729BC2F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9A02F5-09B5-F0A9-DE1E-1113C36AF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39C7E5-9480-EA03-4942-6B109AE4E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80A73E-E36A-7FEB-D73F-B32103039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145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C7C7C-F637-71AB-CA9D-323A4E0A3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E41561-E4FF-D737-B4BE-70F26EB725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89840-C940-FC54-BB05-98A5E96E5E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63EE8F-4560-1C74-6BFC-A4E999DEF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640F4D-C82C-53BB-9100-8B449042A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5DB865-1F15-7507-718F-24CFAB8D3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487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E320D8-7EDD-45D6-85D5-6985B7FFF0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72CDC3-881C-1264-AA6A-88E863AFB8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C3E266-D531-031A-FDD0-20FECA1300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789880-69C6-4E29-BF7E-1573780355F1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3287B-EE15-7C9D-AD75-3886E58EBE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9BF6C-0FC0-F018-21C5-BB8FE0C601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B5257-4439-4CBD-8F4F-3CF20AC10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68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logo&#10;&#10;Description automatically generated">
            <a:extLst>
              <a:ext uri="{FF2B5EF4-FFF2-40B4-BE49-F238E27FC236}">
                <a16:creationId xmlns:a16="http://schemas.microsoft.com/office/drawing/2014/main" id="{EEF3B9CC-805B-5119-FBEC-4CB8F94487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0391" y="2921044"/>
            <a:ext cx="878555" cy="38154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DC4D25E-F88D-E5CE-1A04-8139E725D617}"/>
              </a:ext>
            </a:extLst>
          </p:cNvPr>
          <p:cNvSpPr txBox="1">
            <a:spLocks/>
          </p:cNvSpPr>
          <p:nvPr/>
        </p:nvSpPr>
        <p:spPr>
          <a:xfrm>
            <a:off x="123609" y="454400"/>
            <a:ext cx="11414988" cy="5534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2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</a:rPr>
              <a:t>Figure S3A:  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Calibri" panose="020F0502020204030204" pitchFamily="34" charset="0"/>
                <a:cs typeface="Calibri" panose="020F0502020204030204" pitchFamily="34" charset="0"/>
              </a:rPr>
              <a:t>Percent (%)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Yu Mincho" panose="02020400000000000000" pitchFamily="18" charset="-128"/>
                <a:cs typeface="Calibri" panose="020F0502020204030204" pitchFamily="34" charset="0"/>
              </a:rPr>
              <a:t> Spike IgA Memory B Cells (MBC) in a subset of 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Calibri" panose="020F0502020204030204" pitchFamily="34" charset="0"/>
                <a:cs typeface="Calibri" panose="020F0502020204030204" pitchFamily="34" charset="0"/>
              </a:rPr>
              <a:t>nursing home residents (Georgia, December 2020–July 2022; n=15)</a:t>
            </a:r>
            <a:endParaRPr lang="en-US" sz="1667" b="1" dirty="0">
              <a:solidFill>
                <a:schemeClr val="accent2"/>
              </a:solidFill>
              <a:latin typeface="+mn-lt"/>
            </a:endParaRPr>
          </a:p>
        </p:txBody>
      </p:sp>
      <p:pic>
        <p:nvPicPr>
          <p:cNvPr id="6" name="Picture 5" descr="A picture containing timeline&#10;&#10;Description automatically generated">
            <a:extLst>
              <a:ext uri="{FF2B5EF4-FFF2-40B4-BE49-F238E27FC236}">
                <a16:creationId xmlns:a16="http://schemas.microsoft.com/office/drawing/2014/main" id="{1EAF4F7D-33B6-0BC2-4000-3758675290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1815" y="898235"/>
            <a:ext cx="7998576" cy="53404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470798D-DB84-CBC8-464E-448646B0D49B}"/>
              </a:ext>
            </a:extLst>
          </p:cNvPr>
          <p:cNvSpPr txBox="1"/>
          <p:nvPr/>
        </p:nvSpPr>
        <p:spPr>
          <a:xfrm>
            <a:off x="5082715" y="5978724"/>
            <a:ext cx="205575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Time since vaccine dos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4E2EEAD-C119-EB40-D601-698B216E55A0}"/>
              </a:ext>
            </a:extLst>
          </p:cNvPr>
          <p:cNvSpPr txBox="1"/>
          <p:nvPr/>
        </p:nvSpPr>
        <p:spPr>
          <a:xfrm>
            <a:off x="2198259" y="842115"/>
            <a:ext cx="776833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500" dirty="0"/>
          </a:p>
        </p:txBody>
      </p:sp>
    </p:spTree>
    <p:extLst>
      <p:ext uri="{BB962C8B-B14F-4D97-AF65-F5344CB8AC3E}">
        <p14:creationId xmlns:p14="http://schemas.microsoft.com/office/powerpoint/2010/main" val="41322348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logo&#10;&#10;Description automatically generated">
            <a:extLst>
              <a:ext uri="{FF2B5EF4-FFF2-40B4-BE49-F238E27FC236}">
                <a16:creationId xmlns:a16="http://schemas.microsoft.com/office/drawing/2014/main" id="{EEF3B9CC-805B-5119-FBEC-4CB8F94487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0391" y="2921044"/>
            <a:ext cx="878555" cy="38154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33B2AA4D-98D2-DD4E-F2F7-A541299D4D3F}"/>
              </a:ext>
            </a:extLst>
          </p:cNvPr>
          <p:cNvSpPr txBox="1">
            <a:spLocks/>
          </p:cNvSpPr>
          <p:nvPr/>
        </p:nvSpPr>
        <p:spPr>
          <a:xfrm>
            <a:off x="151176" y="446731"/>
            <a:ext cx="11414988" cy="5534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2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</a:rPr>
              <a:t>Figure S3B: 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Calibri" panose="020F0502020204030204" pitchFamily="34" charset="0"/>
                <a:cs typeface="Calibri" panose="020F0502020204030204" pitchFamily="34" charset="0"/>
              </a:rPr>
              <a:t>Percent (%)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Yu Mincho" panose="02020400000000000000" pitchFamily="18" charset="-128"/>
                <a:cs typeface="Calibri" panose="020F0502020204030204" pitchFamily="34" charset="0"/>
              </a:rPr>
              <a:t> Nucleocapsid IgG Memory B Cells (MBC) in a subset of </a:t>
            </a: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Calibri" panose="020F0502020204030204" pitchFamily="34" charset="0"/>
                <a:cs typeface="Calibri" panose="020F0502020204030204" pitchFamily="34" charset="0"/>
              </a:rPr>
              <a:t>nursing home residents (Georgia, December 2020–July 2022; n=15)</a:t>
            </a:r>
            <a:endParaRPr lang="en-US" sz="1500" dirty="0">
              <a:solidFill>
                <a:schemeClr val="tx1">
                  <a:lumMod val="95000"/>
                  <a:lumOff val="5000"/>
                </a:schemeClr>
              </a:solidFill>
              <a:latin typeface="+mn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667" b="1" dirty="0">
              <a:solidFill>
                <a:schemeClr val="accent2"/>
              </a:solidFill>
            </a:endParaRPr>
          </a:p>
        </p:txBody>
      </p:sp>
      <p:pic>
        <p:nvPicPr>
          <p:cNvPr id="6" name="Picture 5" descr="A picture containing timeline&#10;&#10;Description automatically generated">
            <a:extLst>
              <a:ext uri="{FF2B5EF4-FFF2-40B4-BE49-F238E27FC236}">
                <a16:creationId xmlns:a16="http://schemas.microsoft.com/office/drawing/2014/main" id="{28DCDBA3-5916-BF60-0A13-B757135F951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399" y="911150"/>
            <a:ext cx="7979233" cy="53275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D008E1A-4525-1DD6-9794-54F52A986BFA}"/>
              </a:ext>
            </a:extLst>
          </p:cNvPr>
          <p:cNvSpPr txBox="1"/>
          <p:nvPr/>
        </p:nvSpPr>
        <p:spPr>
          <a:xfrm>
            <a:off x="5082715" y="5978724"/>
            <a:ext cx="205575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Time since vaccine dos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C737497-F119-1FEC-AA37-2DB1C4116133}"/>
              </a:ext>
            </a:extLst>
          </p:cNvPr>
          <p:cNvSpPr txBox="1"/>
          <p:nvPr/>
        </p:nvSpPr>
        <p:spPr>
          <a:xfrm>
            <a:off x="2217074" y="855030"/>
            <a:ext cx="776833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500" dirty="0"/>
          </a:p>
        </p:txBody>
      </p:sp>
    </p:spTree>
    <p:extLst>
      <p:ext uri="{BB962C8B-B14F-4D97-AF65-F5344CB8AC3E}">
        <p14:creationId xmlns:p14="http://schemas.microsoft.com/office/powerpoint/2010/main" val="1342825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logo&#10;&#10;Description automatically generated">
            <a:extLst>
              <a:ext uri="{FF2B5EF4-FFF2-40B4-BE49-F238E27FC236}">
                <a16:creationId xmlns:a16="http://schemas.microsoft.com/office/drawing/2014/main" id="{3315F759-D808-03A7-FC78-E75CFED130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8805" y="2867513"/>
            <a:ext cx="970031" cy="421270"/>
          </a:xfrm>
          <a:prstGeom prst="rect">
            <a:avLst/>
          </a:prstGeom>
        </p:spPr>
      </p:pic>
      <p:pic>
        <p:nvPicPr>
          <p:cNvPr id="5" name="Picture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0D0EA032-1B8D-A29E-9AA8-3CCEE655C7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2470" y="1111008"/>
            <a:ext cx="7772400" cy="518944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B04F671-80B0-BF96-F5E5-883813FDC220}"/>
              </a:ext>
            </a:extLst>
          </p:cNvPr>
          <p:cNvSpPr txBox="1"/>
          <p:nvPr/>
        </p:nvSpPr>
        <p:spPr>
          <a:xfrm>
            <a:off x="5157505" y="6300453"/>
            <a:ext cx="24645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Time since vaccine dose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8E36C529-7317-39D7-2B83-6A3311A192E7}"/>
              </a:ext>
            </a:extLst>
          </p:cNvPr>
          <p:cNvSpPr txBox="1">
            <a:spLocks/>
          </p:cNvSpPr>
          <p:nvPr/>
        </p:nvSpPr>
        <p:spPr>
          <a:xfrm>
            <a:off x="151176" y="373682"/>
            <a:ext cx="11414988" cy="5534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29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</a:rPr>
              <a:t>Figure S3C: </a:t>
            </a:r>
            <a:r>
              <a:rPr lang="en-US" sz="1500" dirty="0">
                <a:effectLst/>
                <a:latin typeface="+mn-lt"/>
                <a:ea typeface="Calibri" panose="020F0502020204030204" pitchFamily="34" charset="0"/>
              </a:rPr>
              <a:t>Percent (%)</a:t>
            </a:r>
            <a:r>
              <a:rPr lang="en-US" sz="1500" kern="1200" dirty="0">
                <a:effectLst/>
                <a:latin typeface="+mn-lt"/>
                <a:ea typeface="Yu Mincho" panose="02020400000000000000" pitchFamily="18" charset="-128"/>
              </a:rPr>
              <a:t> Nucleocapsid IgA Memory B Cells (MBC) in a subset of </a:t>
            </a:r>
            <a:r>
              <a:rPr lang="en-US" sz="1500" dirty="0">
                <a:effectLst/>
                <a:latin typeface="+mn-lt"/>
                <a:ea typeface="Calibri" panose="020F0502020204030204" pitchFamily="34" charset="0"/>
              </a:rPr>
              <a:t>nursing home residents (Georgia, December 2020–July 2022; n=15)</a:t>
            </a:r>
            <a:endParaRPr lang="en-US" sz="1500" dirty="0">
              <a:solidFill>
                <a:schemeClr val="accent2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247713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6</Words>
  <Application>Microsoft Office PowerPoint</Application>
  <PresentationFormat>Widescreen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sty, Zeshan (CDC/NCEZID/DHQP/HSSRTB)</dc:creator>
  <cp:lastModifiedBy>Chisty, Zeshan (CDC/NCEZID/DHQP/HSSRTB)</cp:lastModifiedBy>
  <cp:revision>1</cp:revision>
  <dcterms:created xsi:type="dcterms:W3CDTF">2024-03-25T16:11:06Z</dcterms:created>
  <dcterms:modified xsi:type="dcterms:W3CDTF">2024-03-25T16:14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4-03-25T16:14:17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3f604721-992e-4809-b8a8-323ffa78113a</vt:lpwstr>
  </property>
  <property fmtid="{D5CDD505-2E9C-101B-9397-08002B2CF9AE}" pid="8" name="MSIP_Label_7b94a7b8-f06c-4dfe-bdcc-9b548fd58c31_ContentBits">
    <vt:lpwstr>0</vt:lpwstr>
  </property>
</Properties>
</file>